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5" d="100"/>
          <a:sy n="75" d="100"/>
        </p:scale>
        <p:origin x="51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data\Soybean-BMC0924\&#23454;&#39564;&#39564;&#35777;&#32467;&#26524;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orkdata\Soybean-BMC0924\&#23454;&#39564;&#39564;&#35777;&#32467;&#2652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orkdata\Soybean-BMC0924\&#23454;&#39564;&#39564;&#35777;&#32467;&#2652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orkdata\Soybean-BMC0924\&#23454;&#39564;&#39564;&#35777;&#32467;&#26524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data\Soybean-BMC0924\&#23454;&#39564;&#39564;&#35777;&#32467;&#2652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2910579456358979"/>
          <c:y val="3.7914691943127965E-2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1100"/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8069976163256915"/>
          <c:y val="0.21414549653579676"/>
          <c:w val="0.7680301381576895"/>
          <c:h val="0.600011444067121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qPCR-miRNA'!$E$14</c:f>
              <c:strCache>
                <c:ptCount val="1"/>
                <c:pt idx="0">
                  <c:v>gma-miR160a-5p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qPCR-miRNA'!$B$4,'qPCR-miRNA'!$F$4,'qPCR-miRNA'!$J$4,'qPCR-miRNA'!$N$4)</c:f>
                <c:numCache>
                  <c:formatCode>General</c:formatCode>
                  <c:ptCount val="4"/>
                  <c:pt idx="0">
                    <c:v>5.4904520205196197E-3</c:v>
                  </c:pt>
                  <c:pt idx="1">
                    <c:v>0.233815081428351</c:v>
                  </c:pt>
                  <c:pt idx="2">
                    <c:v>1.16250712524397E-3</c:v>
                  </c:pt>
                  <c:pt idx="3">
                    <c:v>2.22506298530828E-2</c:v>
                  </c:pt>
                </c:numCache>
              </c:numRef>
            </c:plus>
            <c:minus>
              <c:numRef>
                <c:f>('qPCR-miRNA'!$B$4,'qPCR-miRNA'!$F$4,'qPCR-miRNA'!$J$4,'qPCR-miRNA'!$N$4)</c:f>
                <c:numCache>
                  <c:formatCode>General</c:formatCode>
                  <c:ptCount val="4"/>
                  <c:pt idx="0">
                    <c:v>5.4904520205196197E-3</c:v>
                  </c:pt>
                  <c:pt idx="1">
                    <c:v>0.233815081428351</c:v>
                  </c:pt>
                  <c:pt idx="2">
                    <c:v>1.16250712524397E-3</c:v>
                  </c:pt>
                  <c:pt idx="3">
                    <c:v>2.225062985308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qPCR-miRNA'!$D$15:$D$18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'qPCR-miRNA'!$E$15:$E$18</c:f>
              <c:numCache>
                <c:formatCode>General</c:formatCode>
                <c:ptCount val="4"/>
                <c:pt idx="0">
                  <c:v>0.135500514989951</c:v>
                </c:pt>
                <c:pt idx="1">
                  <c:v>3.0162324877759201</c:v>
                </c:pt>
                <c:pt idx="2">
                  <c:v>3.1243439988244099E-2</c:v>
                </c:pt>
                <c:pt idx="3">
                  <c:v>1.00016534116324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-1106032160"/>
        <c:axId val="-1106038688"/>
      </c:barChart>
      <c:catAx>
        <c:axId val="-1106032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zh-CN"/>
          </a:p>
        </c:txPr>
        <c:crossAx val="-1106038688"/>
        <c:crosses val="autoZero"/>
        <c:auto val="1"/>
        <c:lblAlgn val="ctr"/>
        <c:lblOffset val="100"/>
        <c:noMultiLvlLbl val="0"/>
      </c:catAx>
      <c:valAx>
        <c:axId val="-11060386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bundance</a:t>
                </a:r>
              </a:p>
            </c:rich>
          </c:tx>
          <c:layout>
            <c:manualLayout>
              <c:xMode val="edge"/>
              <c:yMode val="edge"/>
              <c:x val="0"/>
              <c:y val="0.2901384483337687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-1106032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4579023664002501"/>
          <c:y val="3.7933094384707287E-2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1200"/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0155343989970223"/>
          <c:y val="0.25731282357626445"/>
          <c:w val="0.74371375959880892"/>
          <c:h val="0.643199422540820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qPCR-miRNA'!$I$14</c:f>
              <c:strCache>
                <c:ptCount val="1"/>
                <c:pt idx="0">
                  <c:v>gma-miR1515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qPCR-miRNA'!$B$5,'qPCR-miRNA'!$F$5,'qPCR-miRNA'!$J$5,'qPCR-miRNA'!$N$5)</c:f>
                <c:numCache>
                  <c:formatCode>General</c:formatCode>
                  <c:ptCount val="4"/>
                  <c:pt idx="0">
                    <c:v>4.8707076119151099E-3</c:v>
                  </c:pt>
                  <c:pt idx="1">
                    <c:v>0.89885659921156402</c:v>
                  </c:pt>
                  <c:pt idx="2">
                    <c:v>6.9864403804612597E-3</c:v>
                  </c:pt>
                  <c:pt idx="3">
                    <c:v>1.2105450338015401E-2</c:v>
                  </c:pt>
                </c:numCache>
              </c:numRef>
            </c:plus>
            <c:minus>
              <c:numRef>
                <c:f>('qPCR-miRNA'!$B$5,'qPCR-miRNA'!$F$5,'qPCR-miRNA'!$J$5,'qPCR-miRNA'!$N$5)</c:f>
                <c:numCache>
                  <c:formatCode>General</c:formatCode>
                  <c:ptCount val="4"/>
                  <c:pt idx="0">
                    <c:v>4.8707076119151099E-3</c:v>
                  </c:pt>
                  <c:pt idx="1">
                    <c:v>0.89885659921156402</c:v>
                  </c:pt>
                  <c:pt idx="2">
                    <c:v>6.9864403804612597E-3</c:v>
                  </c:pt>
                  <c:pt idx="3">
                    <c:v>1.21054503380154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qPCR-miRNA'!$H$15:$H$18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'qPCR-miRNA'!$I$15:$I$18</c:f>
              <c:numCache>
                <c:formatCode>General</c:formatCode>
                <c:ptCount val="4"/>
                <c:pt idx="0">
                  <c:v>0.84506012333645897</c:v>
                </c:pt>
                <c:pt idx="1">
                  <c:v>5.4821650954676402</c:v>
                </c:pt>
                <c:pt idx="2">
                  <c:v>8.6121678939997295E-2</c:v>
                </c:pt>
                <c:pt idx="3">
                  <c:v>0.114950246122026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-1106038144"/>
        <c:axId val="-1106045216"/>
      </c:barChart>
      <c:catAx>
        <c:axId val="-110603814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800"/>
            </a:pPr>
            <a:endParaRPr lang="zh-CN"/>
          </a:p>
        </c:txPr>
        <c:crossAx val="-1106045216"/>
        <c:crosses val="autoZero"/>
        <c:auto val="1"/>
        <c:lblAlgn val="ctr"/>
        <c:lblOffset val="100"/>
        <c:noMultiLvlLbl val="0"/>
      </c:catAx>
      <c:valAx>
        <c:axId val="-11060452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bundance</a:t>
                </a:r>
              </a:p>
            </c:rich>
          </c:tx>
          <c:layout>
            <c:manualLayout>
              <c:xMode val="edge"/>
              <c:yMode val="edge"/>
              <c:x val="3.05513123177336E-2"/>
              <c:y val="0.3728924080111780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-11060381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dirty="0" smtClean="0"/>
              <a:t>Gma-miR160c_Glyma.11G14550</a:t>
            </a:r>
            <a:endParaRPr lang="zh-CN" sz="11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8.5588888888888895E-2"/>
          <c:y val="0.18217444444444444"/>
          <c:w val="0.8659041666666667"/>
          <c:h val="0.4927522222222222"/>
        </c:manualLayout>
      </c:layout>
      <c:lineChart>
        <c:grouping val="standard"/>
        <c:varyColors val="0"/>
        <c:ser>
          <c:idx val="0"/>
          <c:order val="0"/>
          <c:tx>
            <c:strRef>
              <c:f>MTIs!$A$16</c:f>
              <c:strCache>
                <c:ptCount val="1"/>
                <c:pt idx="0">
                  <c:v>gma-miR160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MTIs!$B$15:$E$15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MTIs!$B$16:$E$16</c:f>
              <c:numCache>
                <c:formatCode>General</c:formatCode>
                <c:ptCount val="4"/>
                <c:pt idx="0">
                  <c:v>1.0681511405488</c:v>
                </c:pt>
                <c:pt idx="1">
                  <c:v>1.00887093809339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TIs!$A$17</c:f>
              <c:strCache>
                <c:ptCount val="1"/>
                <c:pt idx="0">
                  <c:v>Glyma.11G145500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MTIs!$B$15:$E$15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MTIs!$B$17:$E$1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.65902886032633901</c:v>
                </c:pt>
                <c:pt idx="3">
                  <c:v>1.9590216675626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106037600"/>
        <c:axId val="-1106037056"/>
      </c:lineChart>
      <c:catAx>
        <c:axId val="-1106037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106037056"/>
        <c:crosses val="autoZero"/>
        <c:auto val="1"/>
        <c:lblAlgn val="ctr"/>
        <c:lblOffset val="100"/>
        <c:noMultiLvlLbl val="0"/>
      </c:catAx>
      <c:valAx>
        <c:axId val="-11060370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1060376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050" dirty="0" smtClean="0"/>
              <a:t>Gma-miRNA160a-5p_Glyma.19181900</a:t>
            </a:r>
            <a:endParaRPr lang="zh-CN" sz="1050" dirty="0"/>
          </a:p>
        </c:rich>
      </c:tx>
      <c:layout>
        <c:manualLayout>
          <c:xMode val="edge"/>
          <c:yMode val="edge"/>
          <c:x val="0.13395972222222222"/>
          <c:y val="4.2333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TIs!$A$24</c:f>
              <c:strCache>
                <c:ptCount val="1"/>
                <c:pt idx="0">
                  <c:v>gma-miR160a-5p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MTIs!$B$23:$E$23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MTIs!$B$24:$E$24</c:f>
              <c:numCache>
                <c:formatCode>General</c:formatCode>
                <c:ptCount val="4"/>
                <c:pt idx="0">
                  <c:v>0.135500514989951</c:v>
                </c:pt>
                <c:pt idx="1">
                  <c:v>3.0162324877759201</c:v>
                </c:pt>
                <c:pt idx="2">
                  <c:v>3.1243439988244099E-2</c:v>
                </c:pt>
                <c:pt idx="3">
                  <c:v>1.00016534116324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TIs!$A$25</c:f>
              <c:strCache>
                <c:ptCount val="1"/>
                <c:pt idx="0">
                  <c:v>Glyma.19G181900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MTIs!$B$23:$E$23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MTIs!$B$25:$E$25</c:f>
              <c:numCache>
                <c:formatCode>General</c:formatCode>
                <c:ptCount val="4"/>
                <c:pt idx="0">
                  <c:v>0.498904932746300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106042496"/>
        <c:axId val="-1106036512"/>
      </c:lineChart>
      <c:catAx>
        <c:axId val="-1106042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106036512"/>
        <c:crosses val="autoZero"/>
        <c:auto val="1"/>
        <c:lblAlgn val="ctr"/>
        <c:lblOffset val="100"/>
        <c:noMultiLvlLbl val="0"/>
      </c:catAx>
      <c:valAx>
        <c:axId val="-11060365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106042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zh-CN" sz="1100"/>
              <a:t> </a:t>
            </a:r>
            <a:r>
              <a:rPr lang="en-US" sz="1100"/>
              <a:t>Gma-miR1515a_Glyma.09G25300</a:t>
            </a:r>
            <a:endParaRPr lang="zh-CN" sz="110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TIs!$A$32</c:f>
              <c:strCache>
                <c:ptCount val="1"/>
                <c:pt idx="0">
                  <c:v>gma-miR1515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MTIs!$B$31:$E$31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MTIs!$B$32:$E$32</c:f>
              <c:numCache>
                <c:formatCode>General</c:formatCode>
                <c:ptCount val="4"/>
                <c:pt idx="0">
                  <c:v>0.84506012333645897</c:v>
                </c:pt>
                <c:pt idx="1">
                  <c:v>5.4821650954676402</c:v>
                </c:pt>
                <c:pt idx="2">
                  <c:v>8.6121678939997295E-2</c:v>
                </c:pt>
                <c:pt idx="3">
                  <c:v>0.114950246122026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TIs!$A$33</c:f>
              <c:strCache>
                <c:ptCount val="1"/>
                <c:pt idx="0">
                  <c:v>Glyma.09G025300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MTIs!$B$31:$E$31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MTIs!$B$33:$E$33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3108043323458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106034336"/>
        <c:axId val="-1106033248"/>
      </c:lineChart>
      <c:catAx>
        <c:axId val="-1106034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106033248"/>
        <c:crosses val="autoZero"/>
        <c:auto val="1"/>
        <c:lblAlgn val="ctr"/>
        <c:lblOffset val="100"/>
        <c:noMultiLvlLbl val="0"/>
      </c:catAx>
      <c:valAx>
        <c:axId val="-11060332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1060343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773236953455571"/>
          <c:y val="3.7933094384707287E-2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1200"/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qPCR-miRNA'!$F$20</c:f>
              <c:strCache>
                <c:ptCount val="1"/>
                <c:pt idx="0">
                  <c:v>gma-miR160c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qPCR-miRNA'!$B$6,'qPCR-miRNA'!$F$6)</c:f>
                <c:numCache>
                  <c:formatCode>General</c:formatCode>
                  <c:ptCount val="2"/>
                  <c:pt idx="0">
                    <c:v>0.49525427652486698</c:v>
                  </c:pt>
                  <c:pt idx="1">
                    <c:v>0.18878861051149601</c:v>
                  </c:pt>
                </c:numCache>
              </c:numRef>
            </c:plus>
            <c:minus>
              <c:numRef>
                <c:f>('qPCR-miRNA'!$B$6,'qPCR-miRNA'!$F$6)</c:f>
                <c:numCache>
                  <c:formatCode>General</c:formatCode>
                  <c:ptCount val="2"/>
                  <c:pt idx="0">
                    <c:v>0.49525427652486698</c:v>
                  </c:pt>
                  <c:pt idx="1">
                    <c:v>0.188788610511496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qPCR-miRNA'!$E$21:$E$24</c:f>
              <c:strCache>
                <c:ptCount val="4"/>
                <c:pt idx="0">
                  <c:v>Root</c:v>
                </c:pt>
                <c:pt idx="1">
                  <c:v>Leaf</c:v>
                </c:pt>
                <c:pt idx="2">
                  <c:v>Cotyledon</c:v>
                </c:pt>
                <c:pt idx="3">
                  <c:v>Seed</c:v>
                </c:pt>
              </c:strCache>
            </c:strRef>
          </c:cat>
          <c:val>
            <c:numRef>
              <c:f>'qPCR-miRNA'!$F$21:$F$24</c:f>
              <c:numCache>
                <c:formatCode>General</c:formatCode>
                <c:ptCount val="4"/>
                <c:pt idx="0">
                  <c:v>1.0681511405488</c:v>
                </c:pt>
                <c:pt idx="1">
                  <c:v>1.00887093809339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-1106032704"/>
        <c:axId val="-1106046848"/>
      </c:barChart>
      <c:catAx>
        <c:axId val="-11060327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800"/>
            </a:pPr>
            <a:endParaRPr lang="zh-CN"/>
          </a:p>
        </c:txPr>
        <c:crossAx val="-1106046848"/>
        <c:crosses val="autoZero"/>
        <c:auto val="1"/>
        <c:lblAlgn val="ctr"/>
        <c:lblOffset val="100"/>
        <c:noMultiLvlLbl val="0"/>
      </c:catAx>
      <c:valAx>
        <c:axId val="-11060468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-1106032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039BC-CA5C-43A9-9107-C8C3C27A839C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5B8815-15C3-4451-ABFA-C3D111DE2D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23590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</a:t>
            </a:r>
            <a:r>
              <a:rPr lang="en-US" altLang="zh-CN" baseline="0" dirty="0" smtClean="0"/>
              <a:t> S2  Expression verification of miRNAs A. </a:t>
            </a:r>
            <a:r>
              <a:rPr lang="en-US" altLang="zh-CN" baseline="0" dirty="0" err="1" smtClean="0"/>
              <a:t>heatmap</a:t>
            </a:r>
            <a:r>
              <a:rPr lang="en-US" altLang="zh-CN" baseline="0" dirty="0" smtClean="0"/>
              <a:t>  of all DEMs B. qPCR results of miRNAs and targets from random MTIs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82EEC9-0167-4003-83A2-2F5C230C2EA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27232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9818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7476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980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201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385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302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674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871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4727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662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4EE55-723C-4F1B-9C5B-AC9E45FFB1B1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9DD0B-69DF-4936-8F59-B6A793DB02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193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3" Type="http://schemas.openxmlformats.org/officeDocument/2006/relationships/image" Target="../media/image1.png"/><Relationship Id="rId7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Relationship Id="rId9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8374" y="218703"/>
            <a:ext cx="3691399" cy="6086563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36728" y="354842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.</a:t>
            </a:r>
            <a:endParaRPr lang="zh-CN" altLang="en-US" dirty="0"/>
          </a:p>
        </p:txBody>
      </p:sp>
      <p:graphicFrame>
        <p:nvGraphicFramePr>
          <p:cNvPr id="18" name="图表 17"/>
          <p:cNvGraphicFramePr>
            <a:graphicFrameLocks/>
          </p:cNvGraphicFramePr>
          <p:nvPr>
            <p:extLst/>
          </p:nvPr>
        </p:nvGraphicFramePr>
        <p:xfrm>
          <a:off x="4969457" y="209701"/>
          <a:ext cx="2553336" cy="2009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图表 18"/>
          <p:cNvGraphicFramePr>
            <a:graphicFrameLocks/>
          </p:cNvGraphicFramePr>
          <p:nvPr>
            <p:extLst/>
          </p:nvPr>
        </p:nvGraphicFramePr>
        <p:xfrm>
          <a:off x="4969457" y="2438248"/>
          <a:ext cx="2552400" cy="200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1" name="图表 20"/>
          <p:cNvGraphicFramePr>
            <a:graphicFrameLocks/>
          </p:cNvGraphicFramePr>
          <p:nvPr>
            <p:extLst/>
          </p:nvPr>
        </p:nvGraphicFramePr>
        <p:xfrm>
          <a:off x="8165947" y="4761218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图表 21"/>
          <p:cNvGraphicFramePr>
            <a:graphicFrameLocks/>
          </p:cNvGraphicFramePr>
          <p:nvPr>
            <p:extLst/>
          </p:nvPr>
        </p:nvGraphicFramePr>
        <p:xfrm>
          <a:off x="8165947" y="314588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3" name="图表 22"/>
          <p:cNvGraphicFramePr>
            <a:graphicFrameLocks/>
          </p:cNvGraphicFramePr>
          <p:nvPr>
            <p:extLst/>
          </p:nvPr>
        </p:nvGraphicFramePr>
        <p:xfrm>
          <a:off x="8165947" y="2542648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4" name="图表 23"/>
          <p:cNvGraphicFramePr>
            <a:graphicFrameLocks/>
          </p:cNvGraphicFramePr>
          <p:nvPr>
            <p:extLst/>
          </p:nvPr>
        </p:nvGraphicFramePr>
        <p:xfrm>
          <a:off x="5085315" y="4656818"/>
          <a:ext cx="2552400" cy="200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5" name="文本框 24"/>
          <p:cNvSpPr txBox="1"/>
          <p:nvPr/>
        </p:nvSpPr>
        <p:spPr>
          <a:xfrm>
            <a:off x="4602049" y="237706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45415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8</Words>
  <Application>Microsoft Office PowerPoint</Application>
  <PresentationFormat>宽屏</PresentationFormat>
  <Paragraphs>1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</cp:revision>
  <dcterms:created xsi:type="dcterms:W3CDTF">2019-05-07T16:04:02Z</dcterms:created>
  <dcterms:modified xsi:type="dcterms:W3CDTF">2019-05-07T16:06:39Z</dcterms:modified>
</cp:coreProperties>
</file>